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799313-EE51-4F52-BC1A-32D70D25E0F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F9BD7D-F0B4-4BD9-94D7-64BF08B814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FD1155-43FC-4CE3-BCDA-A6FF9C2B705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A47DC0-F086-4C65-BCB4-2200F22CE55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ADDCCF-DAD6-4EFA-BE42-EB6D104790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29813F-0660-4BC9-B56C-66F50FD4E6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754122-26C1-48D9-B160-D15D081C0A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E92F57-27D7-4374-814A-C547EED1FF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227FA4-0DE7-4B9C-8D61-C03E86EC3C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2D290F-398D-45A8-9B62-5B3354F690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E2E8D8-BEA6-4250-8DAB-3097ABD896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2EB92B-84FF-4684-8397-45CA4E76F4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C143EEC-C381-4F79-B4B5-7E12952FA580}" type="slidenum">
              <a:rPr b="0" lang="ja-JP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39640" y="7702560"/>
            <a:ext cx="5996160" cy="89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1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Additional file 2: Figure.  All possible fully-resolved trees of the symbiotic bacteria from the stinkbug genus </a:t>
            </a:r>
            <a:r>
              <a:rPr b="0" i="1" lang="ja-JP" sz="1200" spc="-1" strike="noStrike">
                <a:solidFill>
                  <a:srgbClr val="000000"/>
                </a:solidFill>
                <a:latin typeface="Times New Roman"/>
              </a:rPr>
              <a:t>Acanthosoma.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 The unresolved part taken from the symbiont phylogeny (Figure 3) is shown at the top. OTUs are the symbionts of: A, </a:t>
            </a:r>
            <a:r>
              <a:rPr b="0" i="1" lang="ja-JP" sz="1200" spc="-1" strike="noStrike">
                <a:solidFill>
                  <a:srgbClr val="000000"/>
                </a:solidFill>
                <a:latin typeface="Times New Roman"/>
              </a:rPr>
              <a:t>A. haemorrhoidale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; B, </a:t>
            </a:r>
            <a:r>
              <a:rPr b="0" i="1" lang="ja-JP" sz="1200" spc="-1" strike="noStrike">
                <a:solidFill>
                  <a:srgbClr val="000000"/>
                </a:solidFill>
                <a:latin typeface="Times New Roman"/>
              </a:rPr>
              <a:t>A. labiduroides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; C, </a:t>
            </a:r>
            <a:r>
              <a:rPr b="0" i="1" lang="ja-JP" sz="1200" spc="-1" strike="noStrike">
                <a:solidFill>
                  <a:srgbClr val="000000"/>
                </a:solidFill>
                <a:latin typeface="Times New Roman"/>
              </a:rPr>
              <a:t>A. forficula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;</a:t>
            </a:r>
            <a:r>
              <a:rPr b="0" i="1" lang="ja-JP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D, </a:t>
            </a:r>
            <a:r>
              <a:rPr b="0" i="1" lang="ja-JP" sz="1200" spc="-1" strike="noStrike">
                <a:solidFill>
                  <a:srgbClr val="000000"/>
                </a:solidFill>
                <a:latin typeface="Times New Roman"/>
              </a:rPr>
              <a:t>A. denticaudum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;</a:t>
            </a:r>
            <a:r>
              <a:rPr b="0" i="1" lang="ja-JP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and E, </a:t>
            </a:r>
            <a:r>
              <a:rPr b="0" i="1" lang="ja-JP" sz="1200" spc="-1" strike="noStrike">
                <a:solidFill>
                  <a:srgbClr val="000000"/>
                </a:solidFill>
                <a:latin typeface="Times New Roman"/>
              </a:rPr>
              <a:t>A. giganteum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1000080" y="361800"/>
            <a:ext cx="4909320" cy="7216560"/>
            <a:chOff x="1000080" y="361800"/>
            <a:chExt cx="4909320" cy="7216560"/>
          </a:xfrm>
        </p:grpSpPr>
        <p:grpSp>
          <p:nvGrpSpPr>
            <p:cNvPr id="43" name=""/>
            <p:cNvGrpSpPr/>
            <p:nvPr/>
          </p:nvGrpSpPr>
          <p:grpSpPr>
            <a:xfrm>
              <a:off x="1000080" y="2333160"/>
              <a:ext cx="1104120" cy="1452600"/>
              <a:chOff x="1000080" y="2333160"/>
              <a:chExt cx="1104120" cy="1452600"/>
            </a:xfrm>
          </p:grpSpPr>
          <p:sp>
            <p:nvSpPr>
              <p:cNvPr id="44" name=""/>
              <p:cNvSpPr/>
              <p:nvPr/>
            </p:nvSpPr>
            <p:spPr>
              <a:xfrm flipH="1">
                <a:off x="1183680" y="2415240"/>
                <a:ext cx="7628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1975320" y="233316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 flipH="1">
                <a:off x="1375200" y="2730960"/>
                <a:ext cx="5713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1975320" y="265500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 flipH="1">
                <a:off x="1570320" y="3045240"/>
                <a:ext cx="3823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1975320" y="2967120"/>
                <a:ext cx="128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 flipH="1">
                <a:off x="1762560" y="3355920"/>
                <a:ext cx="19008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1975320" y="3278880"/>
                <a:ext cx="128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D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 flipH="1">
                <a:off x="1756800" y="3647520"/>
                <a:ext cx="19008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1975320" y="357228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 flipH="1">
                <a:off x="1570320" y="3484440"/>
                <a:ext cx="1922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1762560" y="3345120"/>
                <a:ext cx="1080" cy="3128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 flipH="1">
                <a:off x="1375200" y="3255120"/>
                <a:ext cx="1897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1576440" y="3034800"/>
                <a:ext cx="1080" cy="4651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 flipH="1">
                <a:off x="1183680" y="2982960"/>
                <a:ext cx="19116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1376640" y="2720160"/>
                <a:ext cx="0" cy="5454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1188720" y="2409840"/>
                <a:ext cx="1080" cy="5835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1000080" y="2701800"/>
                <a:ext cx="18864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2" name=""/>
            <p:cNvGrpSpPr/>
            <p:nvPr/>
          </p:nvGrpSpPr>
          <p:grpSpPr>
            <a:xfrm>
              <a:off x="1000080" y="6125760"/>
              <a:ext cx="1083240" cy="1452600"/>
              <a:chOff x="1000080" y="6125760"/>
              <a:chExt cx="1083240" cy="1452600"/>
            </a:xfrm>
          </p:grpSpPr>
          <p:sp>
            <p:nvSpPr>
              <p:cNvPr id="63" name=""/>
              <p:cNvSpPr/>
              <p:nvPr/>
            </p:nvSpPr>
            <p:spPr>
              <a:xfrm flipH="1" flipV="1">
                <a:off x="1700640" y="6207840"/>
                <a:ext cx="223560" cy="64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1954440" y="612576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 flipH="1">
                <a:off x="1695240" y="6498360"/>
                <a:ext cx="23472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1954440" y="642672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 flipH="1" flipV="1">
                <a:off x="1233000" y="6364080"/>
                <a:ext cx="47844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1701000" y="6197040"/>
                <a:ext cx="0" cy="3117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 flipH="1">
                <a:off x="1461600" y="6820920"/>
                <a:ext cx="46764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1954440" y="6749280"/>
                <a:ext cx="128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 flipH="1">
                <a:off x="1695240" y="7143120"/>
                <a:ext cx="23472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1953720" y="7061040"/>
                <a:ext cx="128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D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 flipH="1">
                <a:off x="1695240" y="7436160"/>
                <a:ext cx="2347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1953720" y="736488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 flipH="1">
                <a:off x="1461600" y="7289280"/>
                <a:ext cx="2329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1701000" y="7132320"/>
                <a:ext cx="0" cy="3142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 flipH="1">
                <a:off x="1233360" y="7048800"/>
                <a:ext cx="23472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1468080" y="6820920"/>
                <a:ext cx="1080" cy="4683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1233360" y="6352560"/>
                <a:ext cx="0" cy="7095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1000080" y="6703920"/>
                <a:ext cx="23328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1" name=""/>
            <p:cNvGrpSpPr/>
            <p:nvPr/>
          </p:nvGrpSpPr>
          <p:grpSpPr>
            <a:xfrm>
              <a:off x="1000080" y="4262040"/>
              <a:ext cx="1104120" cy="1452600"/>
              <a:chOff x="1000080" y="4262040"/>
              <a:chExt cx="1104120" cy="1452600"/>
            </a:xfrm>
          </p:grpSpPr>
          <p:sp>
            <p:nvSpPr>
              <p:cNvPr id="82" name=""/>
              <p:cNvSpPr/>
              <p:nvPr/>
            </p:nvSpPr>
            <p:spPr>
              <a:xfrm flipH="1">
                <a:off x="1183680" y="4344120"/>
                <a:ext cx="7628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1975320" y="426204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 flipH="1">
                <a:off x="1375200" y="4659840"/>
                <a:ext cx="5713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1975320" y="458388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 flipH="1">
                <a:off x="1570320" y="4974120"/>
                <a:ext cx="3823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1975320" y="4896000"/>
                <a:ext cx="128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 flipH="1">
                <a:off x="1762560" y="5284800"/>
                <a:ext cx="19008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1975320" y="5207760"/>
                <a:ext cx="128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D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 flipH="1">
                <a:off x="1756800" y="5576400"/>
                <a:ext cx="19008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1975320" y="550116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 flipH="1">
                <a:off x="1570320" y="5413320"/>
                <a:ext cx="1922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1762560" y="5274000"/>
                <a:ext cx="1080" cy="3128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 flipH="1">
                <a:off x="1375200" y="5184000"/>
                <a:ext cx="1897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1576440" y="4963680"/>
                <a:ext cx="1080" cy="4651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 flipH="1">
                <a:off x="1183680" y="4911840"/>
                <a:ext cx="19116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1376640" y="4649040"/>
                <a:ext cx="0" cy="5454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1188720" y="4338720"/>
                <a:ext cx="1080" cy="5835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1000080" y="4630680"/>
                <a:ext cx="18864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0" name=""/>
            <p:cNvSpPr/>
            <p:nvPr/>
          </p:nvSpPr>
          <p:spPr>
            <a:xfrm>
              <a:off x="1002600" y="1993680"/>
              <a:ext cx="76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Tree 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1002600" y="3871440"/>
              <a:ext cx="76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Tree 4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1002600" y="5778360"/>
              <a:ext cx="76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Tree 7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3" name=""/>
            <p:cNvGrpSpPr/>
            <p:nvPr/>
          </p:nvGrpSpPr>
          <p:grpSpPr>
            <a:xfrm>
              <a:off x="2867040" y="2333160"/>
              <a:ext cx="1104120" cy="1452600"/>
              <a:chOff x="2867040" y="2333160"/>
              <a:chExt cx="1104120" cy="1452600"/>
            </a:xfrm>
          </p:grpSpPr>
          <p:sp>
            <p:nvSpPr>
              <p:cNvPr id="104" name=""/>
              <p:cNvSpPr/>
              <p:nvPr/>
            </p:nvSpPr>
            <p:spPr>
              <a:xfrm flipH="1">
                <a:off x="3050640" y="2415240"/>
                <a:ext cx="7628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3842280" y="233316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 flipH="1">
                <a:off x="3242160" y="2730960"/>
                <a:ext cx="5713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3842280" y="265500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 flipH="1">
                <a:off x="3437280" y="3045240"/>
                <a:ext cx="3823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3842280" y="2967120"/>
                <a:ext cx="128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D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 flipH="1">
                <a:off x="3629520" y="3355920"/>
                <a:ext cx="19008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3842280" y="3278880"/>
                <a:ext cx="128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 flipH="1">
                <a:off x="3623760" y="3647520"/>
                <a:ext cx="19008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3842280" y="357228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 flipH="1">
                <a:off x="3437280" y="3484440"/>
                <a:ext cx="1922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3629520" y="3345120"/>
                <a:ext cx="1080" cy="3128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 flipH="1">
                <a:off x="3242160" y="3255120"/>
                <a:ext cx="1897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3443400" y="3034800"/>
                <a:ext cx="1080" cy="4651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 flipH="1">
                <a:off x="3050640" y="2982960"/>
                <a:ext cx="19116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3243600" y="2720160"/>
                <a:ext cx="0" cy="5454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3055680" y="2409840"/>
                <a:ext cx="1080" cy="5835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2867040" y="2701800"/>
                <a:ext cx="18864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2" name=""/>
            <p:cNvGrpSpPr/>
            <p:nvPr/>
          </p:nvGrpSpPr>
          <p:grpSpPr>
            <a:xfrm>
              <a:off x="2867040" y="4262040"/>
              <a:ext cx="1104120" cy="1452600"/>
              <a:chOff x="2867040" y="4262040"/>
              <a:chExt cx="1104120" cy="1452600"/>
            </a:xfrm>
          </p:grpSpPr>
          <p:sp>
            <p:nvSpPr>
              <p:cNvPr id="123" name=""/>
              <p:cNvSpPr/>
              <p:nvPr/>
            </p:nvSpPr>
            <p:spPr>
              <a:xfrm flipH="1">
                <a:off x="3050640" y="4344120"/>
                <a:ext cx="7628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3842280" y="426204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 flipH="1">
                <a:off x="3242160" y="4659840"/>
                <a:ext cx="5713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3842280" y="458388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 flipH="1">
                <a:off x="3437280" y="4974120"/>
                <a:ext cx="3823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3842280" y="4896000"/>
                <a:ext cx="128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D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 flipH="1">
                <a:off x="3629520" y="5284800"/>
                <a:ext cx="19008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3842280" y="5207760"/>
                <a:ext cx="128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 flipH="1">
                <a:off x="3623760" y="5576400"/>
                <a:ext cx="19008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3842280" y="550116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 flipH="1">
                <a:off x="3437280" y="5413320"/>
                <a:ext cx="1922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3629520" y="5274000"/>
                <a:ext cx="1080" cy="3128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 flipH="1">
                <a:off x="3242160" y="5184000"/>
                <a:ext cx="1897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3443400" y="4963680"/>
                <a:ext cx="1080" cy="4651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 flipH="1">
                <a:off x="3050640" y="4911840"/>
                <a:ext cx="19116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3243600" y="4649040"/>
                <a:ext cx="0" cy="5454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3055680" y="4338720"/>
                <a:ext cx="1080" cy="5835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2867040" y="4630680"/>
                <a:ext cx="18864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1" name=""/>
            <p:cNvGrpSpPr/>
            <p:nvPr/>
          </p:nvGrpSpPr>
          <p:grpSpPr>
            <a:xfrm>
              <a:off x="2867040" y="6125760"/>
              <a:ext cx="1082880" cy="1452600"/>
              <a:chOff x="2867040" y="6125760"/>
              <a:chExt cx="1082880" cy="1452600"/>
            </a:xfrm>
          </p:grpSpPr>
          <p:sp>
            <p:nvSpPr>
              <p:cNvPr id="142" name=""/>
              <p:cNvSpPr/>
              <p:nvPr/>
            </p:nvSpPr>
            <p:spPr>
              <a:xfrm flipH="1" flipV="1">
                <a:off x="3567600" y="6207840"/>
                <a:ext cx="223560" cy="64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3821040" y="612576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 flipH="1">
                <a:off x="3561480" y="6498360"/>
                <a:ext cx="23436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3821040" y="642672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 flipH="1" flipV="1">
                <a:off x="3099960" y="6364080"/>
                <a:ext cx="47844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3567960" y="6197040"/>
                <a:ext cx="0" cy="3117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 flipH="1">
                <a:off x="3328560" y="6820920"/>
                <a:ext cx="46764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3821040" y="6749280"/>
                <a:ext cx="128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D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 flipH="1">
                <a:off x="3561480" y="7143120"/>
                <a:ext cx="23436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3820320" y="7061040"/>
                <a:ext cx="128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 flipH="1">
                <a:off x="3561480" y="7436160"/>
                <a:ext cx="23436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3820320" y="736488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 flipH="1">
                <a:off x="3328560" y="7289280"/>
                <a:ext cx="2329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3567960" y="7132320"/>
                <a:ext cx="0" cy="3142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 flipH="1">
                <a:off x="3099960" y="7048800"/>
                <a:ext cx="23436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3334680" y="6820920"/>
                <a:ext cx="1080" cy="4683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3100320" y="6352560"/>
                <a:ext cx="0" cy="7095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2867040" y="6703920"/>
                <a:ext cx="23328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0" name=""/>
            <p:cNvSpPr/>
            <p:nvPr/>
          </p:nvSpPr>
          <p:spPr>
            <a:xfrm>
              <a:off x="2869560" y="1993680"/>
              <a:ext cx="76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Tree 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2869560" y="3871440"/>
              <a:ext cx="76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Tree 5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2869560" y="5778360"/>
              <a:ext cx="76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Tree 8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3" name=""/>
            <p:cNvGrpSpPr/>
            <p:nvPr/>
          </p:nvGrpSpPr>
          <p:grpSpPr>
            <a:xfrm>
              <a:off x="4734000" y="2333160"/>
              <a:ext cx="1104120" cy="1452600"/>
              <a:chOff x="4734000" y="2333160"/>
              <a:chExt cx="1104120" cy="1452600"/>
            </a:xfrm>
          </p:grpSpPr>
          <p:sp>
            <p:nvSpPr>
              <p:cNvPr id="164" name=""/>
              <p:cNvSpPr/>
              <p:nvPr/>
            </p:nvSpPr>
            <p:spPr>
              <a:xfrm flipH="1">
                <a:off x="4917600" y="2415240"/>
                <a:ext cx="7628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5709240" y="233316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 flipH="1">
                <a:off x="5109120" y="2730960"/>
                <a:ext cx="5713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5709240" y="265500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 flipH="1">
                <a:off x="5304240" y="3045240"/>
                <a:ext cx="3823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5709240" y="296712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 flipH="1">
                <a:off x="5496480" y="3355920"/>
                <a:ext cx="19008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5709240" y="3278880"/>
                <a:ext cx="128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 flipH="1">
                <a:off x="5490720" y="3647520"/>
                <a:ext cx="19008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5709240" y="3572280"/>
                <a:ext cx="128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D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 flipH="1">
                <a:off x="5304240" y="3484440"/>
                <a:ext cx="1922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5496480" y="3345120"/>
                <a:ext cx="1080" cy="3128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 flipH="1">
                <a:off x="5109120" y="3255120"/>
                <a:ext cx="1897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5310360" y="3034800"/>
                <a:ext cx="1080" cy="4651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 flipH="1">
                <a:off x="4917600" y="2982960"/>
                <a:ext cx="19116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5110560" y="2720160"/>
                <a:ext cx="0" cy="5454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4922640" y="2409840"/>
                <a:ext cx="1080" cy="5835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4734000" y="2701800"/>
                <a:ext cx="18864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2" name=""/>
            <p:cNvGrpSpPr/>
            <p:nvPr/>
          </p:nvGrpSpPr>
          <p:grpSpPr>
            <a:xfrm>
              <a:off x="4734000" y="4262040"/>
              <a:ext cx="1104120" cy="1452600"/>
              <a:chOff x="4734000" y="4262040"/>
              <a:chExt cx="1104120" cy="1452600"/>
            </a:xfrm>
          </p:grpSpPr>
          <p:sp>
            <p:nvSpPr>
              <p:cNvPr id="183" name=""/>
              <p:cNvSpPr/>
              <p:nvPr/>
            </p:nvSpPr>
            <p:spPr>
              <a:xfrm flipH="1">
                <a:off x="4917600" y="4344120"/>
                <a:ext cx="7628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5709240" y="426204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 flipH="1">
                <a:off x="5109120" y="4659840"/>
                <a:ext cx="5713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5709240" y="458388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 flipH="1">
                <a:off x="5304240" y="4974120"/>
                <a:ext cx="3823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5709240" y="489600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 flipH="1">
                <a:off x="5496480" y="5284800"/>
                <a:ext cx="19008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5709240" y="5207760"/>
                <a:ext cx="128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 flipH="1">
                <a:off x="5490720" y="5576400"/>
                <a:ext cx="19008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5709240" y="5501160"/>
                <a:ext cx="128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D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 flipH="1">
                <a:off x="5304240" y="5413320"/>
                <a:ext cx="1922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5496480" y="5274000"/>
                <a:ext cx="1080" cy="3128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 flipH="1">
                <a:off x="5109120" y="5184000"/>
                <a:ext cx="1897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5310360" y="4963680"/>
                <a:ext cx="1080" cy="4651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 flipH="1">
                <a:off x="4917600" y="4911840"/>
                <a:ext cx="19116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5110560" y="4649040"/>
                <a:ext cx="0" cy="5454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4922640" y="4338720"/>
                <a:ext cx="1080" cy="5835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4734000" y="4630680"/>
                <a:ext cx="18864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1" name=""/>
            <p:cNvGrpSpPr/>
            <p:nvPr/>
          </p:nvGrpSpPr>
          <p:grpSpPr>
            <a:xfrm>
              <a:off x="4734000" y="6125760"/>
              <a:ext cx="1082880" cy="1452600"/>
              <a:chOff x="4734000" y="6125760"/>
              <a:chExt cx="1082880" cy="1452600"/>
            </a:xfrm>
          </p:grpSpPr>
          <p:sp>
            <p:nvSpPr>
              <p:cNvPr id="202" name=""/>
              <p:cNvSpPr/>
              <p:nvPr/>
            </p:nvSpPr>
            <p:spPr>
              <a:xfrm flipH="1" flipV="1">
                <a:off x="5434560" y="6207840"/>
                <a:ext cx="223560" cy="64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5688000" y="612576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 flipH="1">
                <a:off x="5428440" y="6498360"/>
                <a:ext cx="23436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5688000" y="642672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 flipH="1" flipV="1">
                <a:off x="4966920" y="6364080"/>
                <a:ext cx="47844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5434920" y="6197040"/>
                <a:ext cx="0" cy="3117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 flipH="1">
                <a:off x="5195520" y="6820920"/>
                <a:ext cx="46764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5688000" y="674928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 flipH="1">
                <a:off x="5428440" y="7143120"/>
                <a:ext cx="23436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5688000" y="7061040"/>
                <a:ext cx="128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 flipH="1">
                <a:off x="5428440" y="7436160"/>
                <a:ext cx="23436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5687280" y="7364880"/>
                <a:ext cx="128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D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 flipH="1">
                <a:off x="5195520" y="7289280"/>
                <a:ext cx="23292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5434920" y="7132320"/>
                <a:ext cx="0" cy="3142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 flipH="1">
                <a:off x="4966920" y="7048800"/>
                <a:ext cx="23436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5201640" y="6820920"/>
                <a:ext cx="1080" cy="4683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4967280" y="6352560"/>
                <a:ext cx="0" cy="7095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4734000" y="6703920"/>
                <a:ext cx="23328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20" name=""/>
            <p:cNvSpPr/>
            <p:nvPr/>
          </p:nvSpPr>
          <p:spPr>
            <a:xfrm>
              <a:off x="4736520" y="1993680"/>
              <a:ext cx="76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Tree 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4736520" y="3871440"/>
              <a:ext cx="76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Tree 6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4736520" y="5778360"/>
              <a:ext cx="76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600" spc="-1" strike="noStrike">
                  <a:solidFill>
                    <a:srgbClr val="000000"/>
                  </a:solidFill>
                  <a:latin typeface="Arial"/>
                </a:rPr>
                <a:t>Tree 9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4091760" y="1277640"/>
              <a:ext cx="181764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"/>
                </a:rPr>
                <a:t>Unresolved topolog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"/>
                </a:rPr>
                <a:t>estimated by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"/>
                </a:rPr>
                <a:t>phylogenetic analysis (Fig. 3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24" name=""/>
            <p:cNvGrpSpPr/>
            <p:nvPr/>
          </p:nvGrpSpPr>
          <p:grpSpPr>
            <a:xfrm>
              <a:off x="2867040" y="361800"/>
              <a:ext cx="1114920" cy="1465920"/>
              <a:chOff x="2867040" y="361800"/>
              <a:chExt cx="1114920" cy="1465920"/>
            </a:xfrm>
          </p:grpSpPr>
          <p:sp>
            <p:nvSpPr>
              <p:cNvPr id="225" name=""/>
              <p:cNvSpPr/>
              <p:nvPr/>
            </p:nvSpPr>
            <p:spPr>
              <a:xfrm flipH="1">
                <a:off x="3180960" y="468000"/>
                <a:ext cx="63036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3852720" y="36180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 flipH="1">
                <a:off x="3180960" y="767880"/>
                <a:ext cx="630360" cy="18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3852720" y="67428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 flipH="1">
                <a:off x="3495600" y="1091880"/>
                <a:ext cx="31572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3853080" y="993600"/>
                <a:ext cx="128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3853080" y="1293480"/>
                <a:ext cx="128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D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 flipH="1">
                <a:off x="3495600" y="1695240"/>
                <a:ext cx="31572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>
                <a:off x="3852720" y="1614240"/>
                <a:ext cx="11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 flipH="1">
                <a:off x="3181320" y="1374480"/>
                <a:ext cx="63216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>
                <a:off x="3495960" y="1079280"/>
                <a:ext cx="1440" cy="6285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>
                <a:off x="3181320" y="455400"/>
                <a:ext cx="0" cy="9381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>
                <a:off x="2867040" y="923760"/>
                <a:ext cx="31428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04T02:51:07Z</dcterms:created>
  <dc:creator>菊池 義智</dc:creator>
  <dc:description/>
  <dc:language>en-US</dc:language>
  <cp:lastModifiedBy>菊池 義智</cp:lastModifiedBy>
  <dcterms:modified xsi:type="dcterms:W3CDTF">2008-09-28T12:38:27Z</dcterms:modified>
  <cp:revision>10</cp:revision>
  <dc:subject/>
  <dc:title>PowerPoint プレゼンテーション</dc:title>
</cp:coreProperties>
</file>